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sldIdLst>
    <p:sldId id="256" r:id="rId6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97CEC69-C604-0BE8-FEE0-392ECF2334E5}" name="Lise Becqueriaux" initials="LB" userId="S::Lise.Becqueriaux@genmills.com::28aa6b51-1c7d-47af-94f8-f13fd7a66288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408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microsoft.com/office/2018/10/relationships/authors" Target="authors.xml"/><Relationship Id="rId5" Type="http://schemas.openxmlformats.org/officeDocument/2006/relationships/slideMaster" Target="slideMasters/slideMaster1.xml"/><Relationship Id="rId10" Type="http://schemas.openxmlformats.org/officeDocument/2006/relationships/tableStyles" Target="tableStyles.xml"/><Relationship Id="rId4" Type="http://schemas.openxmlformats.org/officeDocument/2006/relationships/customXml" Target="../customXml/item4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DDA818F-C33C-40DA-F8F2-758ADD4252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47B321D-AEA5-DFF0-8100-451E1C9002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F3F8A14-7379-512C-39F5-427DFDBD6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BC49B31-6EC0-FBA1-9B68-0D7171240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F6F345-0044-47ED-3C63-512D6247E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365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0573C54-0059-03CC-4A95-A0FEBDB9B2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734D0C1-2727-B815-1E1D-2EA1C70609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140230-F6A8-2A72-97F6-1CB68F36A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E09415F-DD8F-DEFC-F7EF-903B34D96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63CFCD5-4841-1822-794A-3E56B4FC4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947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22D7E692-5DED-57DB-0597-DC5DFFBAB6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624F6224-594E-9860-71A8-633BD4206D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D64214-7905-BEEB-8313-6CCBDACB5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1CCBD1A-B90C-D94F-757E-CF69091FE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46E2C0C-3DBD-E687-FD94-FE4945BB2E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160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F080B7-BC0D-324B-6305-5489635A1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439A82F-8FE9-97E3-10D5-FD208F28F8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3B6F555-CB83-4860-D914-44A554497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503734E-D8B8-5428-CEC9-162DAA49B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6502984-1315-ACA4-AE3F-FC1B6257B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5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56FF0CD-9F88-D5F4-E814-DBDB525BA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87AF01D-8D58-0FAF-FFF8-B1AEBF4FA9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A1C8EA0-54F5-9A13-0AD0-E500E4EE85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415C495-E349-24A4-9B79-1D5AF4A67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46F4BF2-8D73-D51D-A053-83436BDB4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650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AD7148-18E4-AEDC-5F44-999BBD580B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5863B2B-BE27-F8E7-0732-4202B73D61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A80A752-1FA4-0886-B213-A0824E0DEC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C5405FA-1F55-16D7-CA36-175267DF3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C23E8C-E02C-D532-E7F4-9270D9CDB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C6F0CED-9046-2C5B-C414-D3AD62EDB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812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CFB2690-EB0B-B11F-6036-B5D4FE0438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20A83C2-98F4-9713-4CBE-586942F47E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DE8CFB8-C413-25C5-911B-1772AEDB9F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99C5B29-7EE1-62C6-7B5C-96192F278A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B7A0107-9C98-0C54-2190-AC676D36D7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239D527-A879-2B12-EDA0-6076F4AF0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2B5E198B-6D0C-2981-907C-D34AE13A0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04AF8CA-7142-95FF-0A14-6604C117A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772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B83EB9-8AA3-F804-8314-7B49967216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044C425-346E-26D3-AC4A-A935DC194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CB74967-D3DF-DD24-012F-DF85FA878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7999D48A-1EFE-C056-6E2B-1AEC2445C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819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A4A96CA-C2CF-58E6-2FC7-0891DD792D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A98D9F20-592A-88C6-ABCD-CBBCA3119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B76B86F-7B76-CB09-95DE-CB0795E43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171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C57BAD3-A6F2-185C-3168-7CABC5286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5F190B8-E284-9484-F231-395B152A2C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A530CC9-BE6B-39E7-4DBE-4001F51F8E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4C9E590-14F5-BD10-D9F7-F2CD03E3C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7AFE60F-849E-19F9-558D-CD0E66877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43DEE52-E4AB-4E14-B7F7-BC01FCEE8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009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5DFBD52-CE4C-CF34-CFCA-1F215C350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8B1FFD25-97E8-2EE4-0029-A162D2B864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C9B6F3D-383B-77F1-A9FD-81526C4641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5607E2B-95B4-F507-7174-487D5F05E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9F6AF54-C9F1-8C2B-F56A-5BCA6E2C6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BBF1687-2297-25F0-FDF7-8B01F43C9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456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4C8A4B48-3F74-3878-2BAE-4AE73337E1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D411260-BD4B-3B11-59BA-0288155DA7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DAE4DE1-19E5-6A9A-B358-A33FFA8766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AAFBF-2CF4-4663-BC03-5843D18F366C}" type="datetimeFigureOut">
              <a:rPr lang="en-US" smtClean="0"/>
              <a:t>1/9/2025</a:t>
            </a:fld>
            <a:endParaRPr lang="en-US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7657DB1-A319-DA5F-62D8-339CD7B89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3162E81-2339-8EBE-0EBC-EE61847BA4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1FDFDE-FBDF-4F2F-A6FB-5905D12E93EC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808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670D389C-F99E-BBE5-D91B-44DBF8198181}"/>
              </a:ext>
            </a:extLst>
          </p:cNvPr>
          <p:cNvSpPr txBox="1"/>
          <p:nvPr/>
        </p:nvSpPr>
        <p:spPr>
          <a:xfrm>
            <a:off x="458024" y="1037146"/>
            <a:ext cx="3565087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Figure S2: </a:t>
            </a:r>
            <a:r>
              <a:rPr lang="en-US" dirty="0"/>
              <a:t>Number of nuts and seeds containing products that bear each number of HSR stars , (by half units from 0.5 up to 5) according to the original HSR (S0) and scenarios S1, S2 and S3, attributed with category 2 thresholds </a:t>
            </a:r>
          </a:p>
          <a:p>
            <a:endParaRPr lang="en-US" dirty="0"/>
          </a:p>
          <a:p>
            <a:r>
              <a:rPr lang="en-US" dirty="0"/>
              <a:t>For original HSR (S0) and for scenario 3, results are also displayed when category 3 (oils and spreads) thresholds are </a:t>
            </a:r>
            <a:r>
              <a:rPr lang="en-US"/>
              <a:t>used (second </a:t>
            </a:r>
            <a:r>
              <a:rPr lang="en-US" dirty="0"/>
              <a:t>and last bars of the histogram). </a:t>
            </a:r>
          </a:p>
          <a:p>
            <a:endParaRPr lang="en-US" dirty="0"/>
          </a:p>
          <a:p>
            <a:endParaRPr lang="fr-FR" dirty="0"/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F70696B4-A232-8785-5145-3E099372AC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3111" y="542000"/>
            <a:ext cx="7352811" cy="55146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84489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PublicationYear xmlns="81b43f1a-5d6c-4e2a-9330-94108ef7dcc8" xsi:nil="true"/>
    <Authors xmlns="81b43f1a-5d6c-4e2a-9330-94108ef7dcc8" xsi:nil="true"/>
    <Hercberg xmlns="81b43f1a-5d6c-4e2a-9330-94108ef7dcc8" xsi:nil="true"/>
    <TaxCatchAll xmlns="ed231b68-6103-4728-94b1-a7c169780aee" xsi:nil="true"/>
    <lcf76f155ced4ddcb4097134ff3c332f xmlns="81b43f1a-5d6c-4e2a-9330-94108ef7dcc8">
      <Terms xmlns="http://schemas.microsoft.com/office/infopath/2007/PartnerControls"/>
    </lcf76f155ced4ddcb4097134ff3c332f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D93910B8EA04044B5373217C3687EF6" ma:contentTypeVersion="21" ma:contentTypeDescription="Create a new document." ma:contentTypeScope="" ma:versionID="bf3fbd03358a03885e7d7e46b17efeb3">
  <xsd:schema xmlns:xsd="http://www.w3.org/2001/XMLSchema" xmlns:xs="http://www.w3.org/2001/XMLSchema" xmlns:p="http://schemas.microsoft.com/office/2006/metadata/properties" xmlns:ns2="81b43f1a-5d6c-4e2a-9330-94108ef7dcc8" xmlns:ns3="9d6671e6-ee19-42b9-b404-80bfd6d6a76c" xmlns:ns4="ed231b68-6103-4728-94b1-a7c169780aee" targetNamespace="http://schemas.microsoft.com/office/2006/metadata/properties" ma:root="true" ma:fieldsID="0c13279231440133145b5bfef34f358c" ns2:_="" ns3:_="" ns4:_="">
    <xsd:import namespace="81b43f1a-5d6c-4e2a-9330-94108ef7dcc8"/>
    <xsd:import namespace="9d6671e6-ee19-42b9-b404-80bfd6d6a76c"/>
    <xsd:import namespace="ed231b68-6103-4728-94b1-a7c169780aee"/>
    <xsd:element name="properties">
      <xsd:complexType>
        <xsd:sequence>
          <xsd:element name="documentManagement">
            <xsd:complexType>
              <xsd:all>
                <xsd:element ref="ns2:lcf76f155ced4ddcb4097134ff3c332f" minOccurs="0"/>
                <xsd:element ref="ns2:Hercberg" minOccurs="0"/>
                <xsd:element ref="ns2:Authors" minOccurs="0"/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LengthInSeconds" minOccurs="0"/>
                <xsd:element ref="ns4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PublicationYear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1b43f1a-5d6c-4e2a-9330-94108ef7dcc8" elementFormDefault="qualified">
    <xsd:import namespace="http://schemas.microsoft.com/office/2006/documentManagement/types"/>
    <xsd:import namespace="http://schemas.microsoft.com/office/infopath/2007/PartnerControls"/>
    <xsd:element name="lcf76f155ced4ddcb4097134ff3c332f" ma:index="3" nillable="true" ma:taxonomy="true" ma:internalName="lcf76f155ced4ddcb4097134ff3c332f" ma:taxonomyFieldName="MediaServiceImageTags" ma:displayName="Image Tags" ma:readOnly="false" ma:fieldId="{5cf76f15-5ced-4ddc-b409-7134ff3c332f}" ma:taxonomyMulti="true" ma:sspId="43ba04b7-a742-4691-b569-1022787fdd07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Hercberg" ma:index="4" nillable="true" ma:displayName="Keywords" ma:format="Dropdown" ma:internalName="Hercberg" ma:readOnly="false">
      <xsd:simpleType>
        <xsd:restriction base="dms:Text">
          <xsd:maxLength value="255"/>
        </xsd:restriction>
      </xsd:simpleType>
    </xsd:element>
    <xsd:element name="Authors" ma:index="5" nillable="true" ma:displayName="Authors" ma:description="Oonagh Markeya,b&#10;, Kirsty E. Kliemc,d" ma:format="Dropdown" ma:internalName="Authors">
      <xsd:simpleType>
        <xsd:restriction base="dms:Note">
          <xsd:maxLength value="255"/>
        </xsd:restriction>
      </xsd:simpleType>
    </xsd:element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hidden="true" ma:internalName="MediaServiceKeyPoints" ma:readOnly="true">
      <xsd:simpleType>
        <xsd:restriction base="dms:Note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5" nillable="true" ma:displayName="Tags" ma:hidden="true" ma:internalName="MediaServiceAutoTags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20" nillable="true" ma:displayName="Extracted Text" ma:hidden="true" ma:internalName="MediaServiceOCR" ma:readOnly="true">
      <xsd:simpleType>
        <xsd:restriction base="dms:Note"/>
      </xsd:simpleType>
    </xsd:element>
    <xsd:element name="MediaServiceGenerationTime" ma:index="2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2" nillable="true" ma:displayName="MediaServiceEventHashCode" ma:hidden="true" ma:internalName="MediaServiceEventHashCode" ma:readOnly="true">
      <xsd:simpleType>
        <xsd:restriction base="dms:Text"/>
      </xsd:simpleType>
    </xsd:element>
    <xsd:element name="PublicationYear" ma:index="25" nillable="true" ma:displayName="Publication Year" ma:description="year of publication" ma:format="Dropdown" ma:internalName="PublicationYear">
      <xsd:simpleType>
        <xsd:restriction base="dms:Text">
          <xsd:maxLength value="255"/>
        </xsd:restriction>
      </xsd:simpleType>
    </xsd:element>
    <xsd:element name="MediaServiceObjectDetectorVersions" ma:index="2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d6671e6-ee19-42b9-b404-80bfd6d6a76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hidden="true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hidden="true" ma:internalName="SharedWithDetail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d231b68-6103-4728-94b1-a7c169780aee" elementFormDefault="qualified">
    <xsd:import namespace="http://schemas.microsoft.com/office/2006/documentManagement/types"/>
    <xsd:import namespace="http://schemas.microsoft.com/office/infopath/2007/PartnerControls"/>
    <xsd:element name="TaxCatchAll" ma:index="19" nillable="true" ma:displayName="Taxonomy Catch All Column" ma:hidden="true" ma:list="{ac6c6ea3-d0b4-48a0-8d54-ed4e9c1c36c5}" ma:internalName="TaxCatchAll" ma:readOnly="false" ma:showField="CatchAllData" ma:web="9d6671e6-ee19-42b9-b404-80bfd6d6a76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displayName="Content Type"/>
        <xsd:element ref="dc:title" minOccurs="0" maxOccurs="1" ma:index="1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4.xml><?xml version="1.0" encoding="utf-8"?>
<?mso-contentType ?>
<SharedContentType xmlns="Microsoft.SharePoint.Taxonomy.ContentTypeSync" SourceId="43ba04b7-a742-4691-b569-1022787fdd07" ContentTypeId="0x01" PreviousValue="false"/>
</file>

<file path=customXml/itemProps1.xml><?xml version="1.0" encoding="utf-8"?>
<ds:datastoreItem xmlns:ds="http://schemas.openxmlformats.org/officeDocument/2006/customXml" ds:itemID="{EA5201D9-3CFE-4FAD-8EB9-016D789378D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0DDEF00-AF3E-4EDC-8C9D-EBA1F57AA116}">
  <ds:schemaRefs>
    <ds:schemaRef ds:uri="http://schemas.microsoft.com/office/2006/metadata/properties"/>
    <ds:schemaRef ds:uri="http://schemas.microsoft.com/office/infopath/2007/PartnerControls"/>
    <ds:schemaRef ds:uri="81b43f1a-5d6c-4e2a-9330-94108ef7dcc8"/>
    <ds:schemaRef ds:uri="ed231b68-6103-4728-94b1-a7c169780aee"/>
  </ds:schemaRefs>
</ds:datastoreItem>
</file>

<file path=customXml/itemProps3.xml><?xml version="1.0" encoding="utf-8"?>
<ds:datastoreItem xmlns:ds="http://schemas.openxmlformats.org/officeDocument/2006/customXml" ds:itemID="{B811BAE4-967C-4949-BFED-FD680E3D81E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1b43f1a-5d6c-4e2a-9330-94108ef7dcc8"/>
    <ds:schemaRef ds:uri="9d6671e6-ee19-42b9-b404-80bfd6d6a76c"/>
    <ds:schemaRef ds:uri="ed231b68-6103-4728-94b1-a7c169780ae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4.xml><?xml version="1.0" encoding="utf-8"?>
<ds:datastoreItem xmlns:ds="http://schemas.openxmlformats.org/officeDocument/2006/customXml" ds:itemID="{DC821C7A-9967-4513-AAB7-D0B027B67AD0}">
  <ds:schemaRefs>
    <ds:schemaRef ds:uri="Microsoft.SharePoint.Taxonomy.ContentTypeSync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84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éronique Braesco</dc:creator>
  <cp:lastModifiedBy>Véronique Braesco</cp:lastModifiedBy>
  <cp:revision>2</cp:revision>
  <dcterms:created xsi:type="dcterms:W3CDTF">2024-12-07T14:15:24Z</dcterms:created>
  <dcterms:modified xsi:type="dcterms:W3CDTF">2025-01-09T17:49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D93910B8EA04044B5373217C3687EF6</vt:lpwstr>
  </property>
</Properties>
</file>